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25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74ED6"/>
    <a:srgbClr val="05BE78"/>
    <a:srgbClr val="FF8080"/>
    <a:srgbClr val="FFFFFF"/>
    <a:srgbClr val="0000FF"/>
    <a:srgbClr val="76069A"/>
    <a:srgbClr val="FF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75"/>
    <p:restoredTop sz="94682"/>
  </p:normalViewPr>
  <p:slideViewPr>
    <p:cSldViewPr snapToGrid="0">
      <p:cViewPr varScale="1">
        <p:scale>
          <a:sx n="69" d="100"/>
          <a:sy n="69" d="100"/>
        </p:scale>
        <p:origin x="1788" y="84"/>
      </p:cViewPr>
      <p:guideLst>
        <p:guide orient="horz" pos="16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2781702D-12D0-4839-A3CC-B3169D578D6E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319DB23-573F-4C71-BB24-19F8F211EC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479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482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681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34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37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02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7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41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106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3754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802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8C5FAE-001F-4F1F-84CB-5BCAEE7B2AF2}" type="datetimeFigureOut">
              <a:rPr lang="en-US" smtClean="0"/>
              <a:t>7/2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7BA4BC5-A43A-4BDF-B5AE-CCBFF1C1E6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7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8216933-99F9-9C1B-D3E5-53444594935B}"/>
              </a:ext>
            </a:extLst>
          </p:cNvPr>
          <p:cNvSpPr txBox="1"/>
          <p:nvPr/>
        </p:nvSpPr>
        <p:spPr>
          <a:xfrm>
            <a:off x="212242" y="3829110"/>
            <a:ext cx="6478117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tabLst>
                <a:tab pos="1068705" algn="l"/>
              </a:tabLst>
            </a:pPr>
            <a:r>
              <a:rPr lang="en-US" sz="1100" b="1" kern="10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Figure S17</a:t>
            </a:r>
            <a:r>
              <a:rPr lang="en-US" sz="11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 EWS::FLI1 expression in tumors established in hu-mice. </a:t>
            </a:r>
            <a:r>
              <a:rPr lang="en-US" sz="11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NA was extracted from Ewing sarcoma tumors established utilizing the TC32 Ewing cell line. EWS::FLI1 expression was determined utilizing RT-PCR. RPLPO was utilized as a housekeeper gene. Expression of EWS::FLI1 was compared between Ewing sarcoma tumors in  Hu-CD34+ mice treated with +/- single fraction of radiation therapy and +/- RER (left panel). Tumors were additionally established in NSG immune deficient mice and compared to tumors in the humanized mouse model (right panel). </a:t>
            </a:r>
            <a:r>
              <a:rPr lang="en-US" sz="1100" kern="100" dirty="0"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-value  was &gt; 0.05 for all comparisons (non-significant). </a:t>
            </a:r>
            <a:endParaRPr lang="en-US" sz="11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6937654-619E-1881-1B55-2AF850F41E7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10344" b="26051"/>
          <a:stretch/>
        </p:blipFill>
        <p:spPr>
          <a:xfrm>
            <a:off x="31557" y="433342"/>
            <a:ext cx="4366641" cy="263280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08AA471-7BBD-FE4A-3F88-EFDE10AE3FC3}"/>
              </a:ext>
            </a:extLst>
          </p:cNvPr>
          <p:cNvSpPr txBox="1"/>
          <p:nvPr/>
        </p:nvSpPr>
        <p:spPr>
          <a:xfrm rot="16200000">
            <a:off x="-885008" y="1540341"/>
            <a:ext cx="263281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EWSR1::FLI1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pression relative to untreated tumor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61932D-98E7-FA1C-177A-259D4D0BCFE9}"/>
              </a:ext>
            </a:extLst>
          </p:cNvPr>
          <p:cNvSpPr txBox="1"/>
          <p:nvPr/>
        </p:nvSpPr>
        <p:spPr>
          <a:xfrm>
            <a:off x="1069092" y="3055577"/>
            <a:ext cx="7142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BS,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No R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56B254-C3EC-23BE-C07D-A8FD2ED99671}"/>
              </a:ext>
            </a:extLst>
          </p:cNvPr>
          <p:cNvSpPr txBox="1"/>
          <p:nvPr/>
        </p:nvSpPr>
        <p:spPr>
          <a:xfrm>
            <a:off x="1622010" y="3055577"/>
            <a:ext cx="7142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BS, 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5 Gy RT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A513B32-238F-7E87-E443-4740E116E33B}"/>
              </a:ext>
            </a:extLst>
          </p:cNvPr>
          <p:cNvSpPr txBox="1"/>
          <p:nvPr/>
        </p:nvSpPr>
        <p:spPr>
          <a:xfrm>
            <a:off x="2125082" y="3055577"/>
            <a:ext cx="7208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ER,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No R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8087620-ADBD-D0D0-121B-1E4115231C99}"/>
              </a:ext>
            </a:extLst>
          </p:cNvPr>
          <p:cNvSpPr txBox="1"/>
          <p:nvPr/>
        </p:nvSpPr>
        <p:spPr>
          <a:xfrm>
            <a:off x="2655998" y="3055577"/>
            <a:ext cx="8603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ER,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5 Gy RT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99D976CE-1180-29D3-60DD-496CF3E466C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2972" t="9964" r="30789" b="34079"/>
          <a:stretch/>
        </p:blipFill>
        <p:spPr>
          <a:xfrm>
            <a:off x="3721215" y="433342"/>
            <a:ext cx="2459802" cy="267557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68C9F7C-A9E9-B491-7A46-E9A5EA7837F1}"/>
              </a:ext>
            </a:extLst>
          </p:cNvPr>
          <p:cNvSpPr txBox="1"/>
          <p:nvPr/>
        </p:nvSpPr>
        <p:spPr>
          <a:xfrm>
            <a:off x="4445314" y="3118356"/>
            <a:ext cx="7208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u-Mic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C07EB97-E973-9DC4-67B1-16BD38FC0261}"/>
              </a:ext>
            </a:extLst>
          </p:cNvPr>
          <p:cNvSpPr txBox="1"/>
          <p:nvPr/>
        </p:nvSpPr>
        <p:spPr>
          <a:xfrm>
            <a:off x="4805755" y="3118356"/>
            <a:ext cx="15325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SG mic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45CD59D-84E6-EFB8-108D-30F81EE83591}"/>
              </a:ext>
            </a:extLst>
          </p:cNvPr>
          <p:cNvSpPr txBox="1"/>
          <p:nvPr/>
        </p:nvSpPr>
        <p:spPr>
          <a:xfrm rot="16200000">
            <a:off x="2430977" y="1540340"/>
            <a:ext cx="251926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 dirty="0">
                <a:latin typeface="Arial" panose="020B0604020202020204" pitchFamily="34" charset="0"/>
                <a:cs typeface="Arial" panose="020B0604020202020204" pitchFamily="34" charset="0"/>
              </a:rPr>
              <a:t>EWSR1::FLI1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xpression relative to housekeeper</a:t>
            </a:r>
          </a:p>
        </p:txBody>
      </p:sp>
    </p:spTree>
    <p:extLst>
      <p:ext uri="{BB962C8B-B14F-4D97-AF65-F5344CB8AC3E}">
        <p14:creationId xmlns:p14="http://schemas.microsoft.com/office/powerpoint/2010/main" val="8664949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9ef9f489-e0a0-4eeb-87cc-3a526112fd0d}" enabled="0" method="" siteId="{9ef9f489-e0a0-4eeb-87cc-3a526112fd0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146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ley, Jessica</dc:creator>
  <cp:lastModifiedBy>Bailey, Kelly Margaret</cp:lastModifiedBy>
  <cp:revision>5</cp:revision>
  <cp:lastPrinted>2025-05-16T17:21:58Z</cp:lastPrinted>
  <dcterms:created xsi:type="dcterms:W3CDTF">2024-03-08T16:05:53Z</dcterms:created>
  <dcterms:modified xsi:type="dcterms:W3CDTF">2025-07-22T15:10:58Z</dcterms:modified>
</cp:coreProperties>
</file>